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8" r:id="rId2"/>
    <p:sldId id="260" r:id="rId3"/>
  </p:sldIdLst>
  <p:sldSz cx="9144000" cy="5143500" type="screen16x9"/>
  <p:notesSz cx="6858000" cy="9144000"/>
  <p:defaultTextStyle>
    <a:defPPr>
      <a:defRPr lang="en-US"/>
    </a:defPPr>
    <a:lvl1pPr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ptos" panose="020B0004020202020204" pitchFamily="34" charset="0"/>
        <a:ea typeface="+mn-ea"/>
        <a:cs typeface="+mn-cs"/>
      </a:defRPr>
    </a:lvl1pPr>
    <a:lvl2pPr marL="4572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ptos" panose="020B0004020202020204" pitchFamily="34" charset="0"/>
        <a:ea typeface="+mn-ea"/>
        <a:cs typeface="+mn-cs"/>
      </a:defRPr>
    </a:lvl2pPr>
    <a:lvl3pPr marL="9144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ptos" panose="020B0004020202020204" pitchFamily="34" charset="0"/>
        <a:ea typeface="+mn-ea"/>
        <a:cs typeface="+mn-cs"/>
      </a:defRPr>
    </a:lvl3pPr>
    <a:lvl4pPr marL="13716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ptos" panose="020B0004020202020204" pitchFamily="34" charset="0"/>
        <a:ea typeface="+mn-ea"/>
        <a:cs typeface="+mn-cs"/>
      </a:defRPr>
    </a:lvl4pPr>
    <a:lvl5pPr marL="18288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ptos" panose="020B0004020202020204" pitchFamily="34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ptos" panose="020B0004020202020204" pitchFamily="34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ptos" panose="020B0004020202020204" pitchFamily="34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ptos" panose="020B0004020202020204" pitchFamily="34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ptos" panose="020B0004020202020204" pitchFamily="34" charset="0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D0D84A80-CE1A-4ADD-A5D6-71699BD26863}">
          <p14:sldIdLst/>
        </p14:section>
        <p14:section name="Untitled Section" id="{A2CCFE4C-EF63-491B-AD2E-AD524F6B4059}">
          <p14:sldIdLst>
            <p14:sldId id="268"/>
            <p14:sldId id="260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162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87" d="100"/>
          <a:sy n="87" d="100"/>
        </p:scale>
        <p:origin x="906" y="72"/>
      </p:cViewPr>
      <p:guideLst>
        <p:guide orient="horz" pos="162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43000" y="841772"/>
            <a:ext cx="6858000" cy="17907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2701528"/>
            <a:ext cx="6858000" cy="124182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5C8453B-90C4-A5EB-0B81-753C10CA0D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EF955DC-C7C1-4376-9534-E92E57EBDDDB}" type="datetimeFigureOut">
              <a:rPr lang="ar-YE"/>
              <a:pPr>
                <a:defRPr/>
              </a:pPr>
              <a:t>21/11/1447</a:t>
            </a:fld>
            <a:endParaRPr lang="ar-Y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E57893A-0A44-7816-5EAD-6D33A8B5DC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ar-Y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E88B4FE-6063-6855-9B98-8AAA0258A4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AB93433F-34DA-4C69-92AD-F7FC1E3C2F96}" type="slidenum">
              <a:rPr lang="ar-YE" altLang="ar-YE"/>
              <a:pPr/>
              <a:t>‹#›</a:t>
            </a:fld>
            <a:endParaRPr lang="ar-YE" altLang="ar-YE"/>
          </a:p>
        </p:txBody>
      </p:sp>
    </p:spTree>
    <p:extLst>
      <p:ext uri="{BB962C8B-B14F-4D97-AF65-F5344CB8AC3E}">
        <p14:creationId xmlns:p14="http://schemas.microsoft.com/office/powerpoint/2010/main" val="28399575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623351E-E0D2-01B5-78B6-5B60527CE1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69BAF80-B914-4C1A-BE4E-3B42C85AEC71}" type="datetimeFigureOut">
              <a:rPr lang="ar-YE"/>
              <a:pPr>
                <a:defRPr/>
              </a:pPr>
              <a:t>21/11/1447</a:t>
            </a:fld>
            <a:endParaRPr lang="ar-Y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ED426FF-254F-7656-FD21-6950B40D89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ar-Y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BBA51D4-C21A-D49D-7997-AE8E4EB0DE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3CA40401-FB40-434F-806C-46E51DAE8CF1}" type="slidenum">
              <a:rPr lang="ar-YE" altLang="ar-YE"/>
              <a:pPr/>
              <a:t>‹#›</a:t>
            </a:fld>
            <a:endParaRPr lang="ar-YE" altLang="ar-YE"/>
          </a:p>
        </p:txBody>
      </p:sp>
    </p:spTree>
    <p:extLst>
      <p:ext uri="{BB962C8B-B14F-4D97-AF65-F5344CB8AC3E}">
        <p14:creationId xmlns:p14="http://schemas.microsoft.com/office/powerpoint/2010/main" val="4047213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273844"/>
            <a:ext cx="1971675" cy="435887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273844"/>
            <a:ext cx="5800725" cy="435887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2EEC6A0-5E7A-346F-EDD6-92C02A651F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518C23E-DF59-48E9-BEE9-32AC4128E6B7}" type="datetimeFigureOut">
              <a:rPr lang="ar-YE"/>
              <a:pPr>
                <a:defRPr/>
              </a:pPr>
              <a:t>21/11/1447</a:t>
            </a:fld>
            <a:endParaRPr lang="ar-Y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EE6EB7D-C592-A7B5-7DC4-0D51D5DE79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ar-Y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64F9589-8F4B-880D-1DAA-D8EDC90563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CAF9A0D-A95F-4A2B-89C4-0C13CF3957EB}" type="slidenum">
              <a:rPr lang="ar-YE" altLang="ar-YE"/>
              <a:pPr/>
              <a:t>‹#›</a:t>
            </a:fld>
            <a:endParaRPr lang="ar-YE" altLang="ar-YE"/>
          </a:p>
        </p:txBody>
      </p:sp>
    </p:spTree>
    <p:extLst>
      <p:ext uri="{BB962C8B-B14F-4D97-AF65-F5344CB8AC3E}">
        <p14:creationId xmlns:p14="http://schemas.microsoft.com/office/powerpoint/2010/main" val="41694321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2211EDE-7073-2202-9155-2CDB569AC3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6496D4-D55C-4279-9A96-FF9BBB5260DE}" type="datetimeFigureOut">
              <a:rPr lang="ar-YE"/>
              <a:pPr>
                <a:defRPr/>
              </a:pPr>
              <a:t>21/11/1447</a:t>
            </a:fld>
            <a:endParaRPr lang="ar-Y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D4D387E-6EAE-95EC-9B0D-D48EA68D5C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ar-Y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CDB3C6F-B9E3-D9B9-6F11-8230479226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9CDDE7DE-AD13-4FAA-8224-CED41ED18AA8}" type="slidenum">
              <a:rPr lang="ar-YE" altLang="ar-YE"/>
              <a:pPr/>
              <a:t>‹#›</a:t>
            </a:fld>
            <a:endParaRPr lang="ar-YE" altLang="ar-YE"/>
          </a:p>
        </p:txBody>
      </p:sp>
    </p:spTree>
    <p:extLst>
      <p:ext uri="{BB962C8B-B14F-4D97-AF65-F5344CB8AC3E}">
        <p14:creationId xmlns:p14="http://schemas.microsoft.com/office/powerpoint/2010/main" val="42473128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282304"/>
            <a:ext cx="7886700" cy="2139553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3442098"/>
            <a:ext cx="7886700" cy="1125140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651D4B2-51D9-F669-DC71-933217BD21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E688E2F-CA85-4EBF-A7CE-ED2F0151CFE6}" type="datetimeFigureOut">
              <a:rPr lang="ar-YE"/>
              <a:pPr>
                <a:defRPr/>
              </a:pPr>
              <a:t>21/11/1447</a:t>
            </a:fld>
            <a:endParaRPr lang="ar-Y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1A302B2-921D-5B8C-02DF-2393AA7AF3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ar-Y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55B5777-2A9A-3D46-7C1F-51CA849BE2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6154E6B-3393-42B2-A519-A5E57359B0C5}" type="slidenum">
              <a:rPr lang="ar-YE" altLang="ar-YE"/>
              <a:pPr/>
              <a:t>‹#›</a:t>
            </a:fld>
            <a:endParaRPr lang="ar-YE" altLang="ar-YE"/>
          </a:p>
        </p:txBody>
      </p:sp>
    </p:spTree>
    <p:extLst>
      <p:ext uri="{BB962C8B-B14F-4D97-AF65-F5344CB8AC3E}">
        <p14:creationId xmlns:p14="http://schemas.microsoft.com/office/powerpoint/2010/main" val="4318393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369219"/>
            <a:ext cx="3886200" cy="326350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369219"/>
            <a:ext cx="3886200" cy="326350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1D1BB1AF-A5F6-AB98-9FE0-5D8056ABBB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357D44B-DCFE-4542-8037-E2F89F857E4B}" type="datetimeFigureOut">
              <a:rPr lang="ar-YE"/>
              <a:pPr>
                <a:defRPr/>
              </a:pPr>
              <a:t>21/11/1447</a:t>
            </a:fld>
            <a:endParaRPr lang="ar-YE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D63195A3-6C94-BECF-ADFA-F600E7BD4F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ar-YE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9E096395-C0FE-B7CC-C5B7-3E39643358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0CD20EF-1CA4-45F0-B212-CF6C7EBC03A7}" type="slidenum">
              <a:rPr lang="ar-YE" altLang="ar-YE"/>
              <a:pPr/>
              <a:t>‹#›</a:t>
            </a:fld>
            <a:endParaRPr lang="ar-YE" altLang="ar-YE"/>
          </a:p>
        </p:txBody>
      </p:sp>
    </p:spTree>
    <p:extLst>
      <p:ext uri="{BB962C8B-B14F-4D97-AF65-F5344CB8AC3E}">
        <p14:creationId xmlns:p14="http://schemas.microsoft.com/office/powerpoint/2010/main" val="31465330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273844"/>
            <a:ext cx="7886700" cy="99417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260872"/>
            <a:ext cx="3868340" cy="617934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1878806"/>
            <a:ext cx="3868340" cy="276344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260872"/>
            <a:ext cx="3887391" cy="617934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1878806"/>
            <a:ext cx="3887391" cy="276344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3">
            <a:extLst>
              <a:ext uri="{FF2B5EF4-FFF2-40B4-BE49-F238E27FC236}">
                <a16:creationId xmlns:a16="http://schemas.microsoft.com/office/drawing/2014/main" id="{7884EBDA-9F96-65CB-8C91-EAB789826E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8F33588-C768-42F3-B320-CA9D66169FC6}" type="datetimeFigureOut">
              <a:rPr lang="ar-YE"/>
              <a:pPr>
                <a:defRPr/>
              </a:pPr>
              <a:t>21/11/1447</a:t>
            </a:fld>
            <a:endParaRPr lang="ar-YE"/>
          </a:p>
        </p:txBody>
      </p:sp>
      <p:sp>
        <p:nvSpPr>
          <p:cNvPr id="8" name="Footer Placeholder 4">
            <a:extLst>
              <a:ext uri="{FF2B5EF4-FFF2-40B4-BE49-F238E27FC236}">
                <a16:creationId xmlns:a16="http://schemas.microsoft.com/office/drawing/2014/main" id="{C6673F07-4BF2-539B-F064-3C01C814BE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ar-YE"/>
          </a:p>
        </p:txBody>
      </p:sp>
      <p:sp>
        <p:nvSpPr>
          <p:cNvPr id="9" name="Slide Number Placeholder 5">
            <a:extLst>
              <a:ext uri="{FF2B5EF4-FFF2-40B4-BE49-F238E27FC236}">
                <a16:creationId xmlns:a16="http://schemas.microsoft.com/office/drawing/2014/main" id="{2595270C-309B-6A76-E0A2-69D7B6144C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0EBC293B-7CA6-487F-B4A5-E2E65FFBB48E}" type="slidenum">
              <a:rPr lang="ar-YE" altLang="ar-YE"/>
              <a:pPr/>
              <a:t>‹#›</a:t>
            </a:fld>
            <a:endParaRPr lang="ar-YE" altLang="ar-YE"/>
          </a:p>
        </p:txBody>
      </p:sp>
    </p:spTree>
    <p:extLst>
      <p:ext uri="{BB962C8B-B14F-4D97-AF65-F5344CB8AC3E}">
        <p14:creationId xmlns:p14="http://schemas.microsoft.com/office/powerpoint/2010/main" val="37475109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3">
            <a:extLst>
              <a:ext uri="{FF2B5EF4-FFF2-40B4-BE49-F238E27FC236}">
                <a16:creationId xmlns:a16="http://schemas.microsoft.com/office/drawing/2014/main" id="{5388E6E5-2972-90D8-0D59-B553E3A16C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35B427F-F011-4806-ABDD-BCB025D97FB6}" type="datetimeFigureOut">
              <a:rPr lang="ar-YE"/>
              <a:pPr>
                <a:defRPr/>
              </a:pPr>
              <a:t>21/11/1447</a:t>
            </a:fld>
            <a:endParaRPr lang="ar-YE"/>
          </a:p>
        </p:txBody>
      </p:sp>
      <p:sp>
        <p:nvSpPr>
          <p:cNvPr id="4" name="Footer Placeholder 4">
            <a:extLst>
              <a:ext uri="{FF2B5EF4-FFF2-40B4-BE49-F238E27FC236}">
                <a16:creationId xmlns:a16="http://schemas.microsoft.com/office/drawing/2014/main" id="{1FD084FB-A36D-4FBB-3AE0-C91CA0E850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ar-YE"/>
          </a:p>
        </p:txBody>
      </p:sp>
      <p:sp>
        <p:nvSpPr>
          <p:cNvPr id="5" name="Slide Number Placeholder 5">
            <a:extLst>
              <a:ext uri="{FF2B5EF4-FFF2-40B4-BE49-F238E27FC236}">
                <a16:creationId xmlns:a16="http://schemas.microsoft.com/office/drawing/2014/main" id="{566E01CD-3B7F-AF05-4489-98E6F9DDA1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BE2C52B1-5DEE-4F53-B88B-35B8519700EB}" type="slidenum">
              <a:rPr lang="ar-YE" altLang="ar-YE"/>
              <a:pPr/>
              <a:t>‹#›</a:t>
            </a:fld>
            <a:endParaRPr lang="ar-YE" altLang="ar-YE"/>
          </a:p>
        </p:txBody>
      </p:sp>
    </p:spTree>
    <p:extLst>
      <p:ext uri="{BB962C8B-B14F-4D97-AF65-F5344CB8AC3E}">
        <p14:creationId xmlns:p14="http://schemas.microsoft.com/office/powerpoint/2010/main" val="16856325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>
            <a:extLst>
              <a:ext uri="{FF2B5EF4-FFF2-40B4-BE49-F238E27FC236}">
                <a16:creationId xmlns:a16="http://schemas.microsoft.com/office/drawing/2014/main" id="{D808274A-3A5D-4BDA-9028-1CEC991E84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E14E764-C10B-4DAC-98D8-A573F5949B81}" type="datetimeFigureOut">
              <a:rPr lang="ar-YE"/>
              <a:pPr>
                <a:defRPr/>
              </a:pPr>
              <a:t>21/11/1447</a:t>
            </a:fld>
            <a:endParaRPr lang="ar-YE"/>
          </a:p>
        </p:txBody>
      </p:sp>
      <p:sp>
        <p:nvSpPr>
          <p:cNvPr id="3" name="Footer Placeholder 4">
            <a:extLst>
              <a:ext uri="{FF2B5EF4-FFF2-40B4-BE49-F238E27FC236}">
                <a16:creationId xmlns:a16="http://schemas.microsoft.com/office/drawing/2014/main" id="{C0D4B752-7E7C-033E-E1AB-DF2A5B036F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ar-YE"/>
          </a:p>
        </p:txBody>
      </p:sp>
      <p:sp>
        <p:nvSpPr>
          <p:cNvPr id="4" name="Slide Number Placeholder 5">
            <a:extLst>
              <a:ext uri="{FF2B5EF4-FFF2-40B4-BE49-F238E27FC236}">
                <a16:creationId xmlns:a16="http://schemas.microsoft.com/office/drawing/2014/main" id="{BFB4D461-81FB-2237-CB38-7FAED3E18C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F507B75A-CC9D-4F89-BC20-8F2CF2E7E54D}" type="slidenum">
              <a:rPr lang="ar-YE" altLang="ar-YE"/>
              <a:pPr/>
              <a:t>‹#›</a:t>
            </a:fld>
            <a:endParaRPr lang="ar-YE" altLang="ar-YE"/>
          </a:p>
        </p:txBody>
      </p:sp>
    </p:spTree>
    <p:extLst>
      <p:ext uri="{BB962C8B-B14F-4D97-AF65-F5344CB8AC3E}">
        <p14:creationId xmlns:p14="http://schemas.microsoft.com/office/powerpoint/2010/main" val="23343226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42900"/>
            <a:ext cx="2949178" cy="120015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740569"/>
            <a:ext cx="4629150" cy="3655219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1543050"/>
            <a:ext cx="2949178" cy="2858691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4946A807-79E0-C924-F632-B0FC9DDB4F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A57B315-1BC6-494C-BFE9-0E64193A442B}" type="datetimeFigureOut">
              <a:rPr lang="ar-YE"/>
              <a:pPr>
                <a:defRPr/>
              </a:pPr>
              <a:t>21/11/1447</a:t>
            </a:fld>
            <a:endParaRPr lang="ar-YE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3E3BFBEA-C487-3C5D-4A81-0FD606912A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ar-YE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D071BBDF-D2BE-E117-614B-35A7CEB081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639EC089-A1E2-4348-A6F0-62BCC7C13DAB}" type="slidenum">
              <a:rPr lang="ar-YE" altLang="ar-YE"/>
              <a:pPr/>
              <a:t>‹#›</a:t>
            </a:fld>
            <a:endParaRPr lang="ar-YE" altLang="ar-YE"/>
          </a:p>
        </p:txBody>
      </p:sp>
    </p:spTree>
    <p:extLst>
      <p:ext uri="{BB962C8B-B14F-4D97-AF65-F5344CB8AC3E}">
        <p14:creationId xmlns:p14="http://schemas.microsoft.com/office/powerpoint/2010/main" val="11136413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42900"/>
            <a:ext cx="2949178" cy="120015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740569"/>
            <a:ext cx="4629150" cy="3655219"/>
          </a:xfrm>
        </p:spPr>
        <p:txBody>
          <a:bodyPr rtlCol="0">
            <a:normAutofit/>
          </a:bodyPr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pPr lvl="0"/>
            <a:r>
              <a:rPr lang="en-US" noProof="0"/>
              <a:t>Click icon to add picture</a:t>
            </a:r>
            <a:endParaRPr lang="en-US" noProof="0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1543050"/>
            <a:ext cx="2949178" cy="2858691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92AB9644-9619-DE4D-A625-5F1CA37E37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1172EA2-86FE-4500-9270-7D9CAFD90180}" type="datetimeFigureOut">
              <a:rPr lang="ar-YE"/>
              <a:pPr>
                <a:defRPr/>
              </a:pPr>
              <a:t>21/11/1447</a:t>
            </a:fld>
            <a:endParaRPr lang="ar-YE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6AD111D1-10A9-EB92-9A2D-994E148CF4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ar-YE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C20702F5-837A-94B3-70F1-3B0DBA6567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0AE934D1-4156-4698-81F1-1C3A6887CEC5}" type="slidenum">
              <a:rPr lang="ar-YE" altLang="ar-YE"/>
              <a:pPr/>
              <a:t>‹#›</a:t>
            </a:fld>
            <a:endParaRPr lang="ar-YE" altLang="ar-YE"/>
          </a:p>
        </p:txBody>
      </p:sp>
    </p:spTree>
    <p:extLst>
      <p:ext uri="{BB962C8B-B14F-4D97-AF65-F5344CB8AC3E}">
        <p14:creationId xmlns:p14="http://schemas.microsoft.com/office/powerpoint/2010/main" val="2728939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>
            <a:extLst>
              <a:ext uri="{FF2B5EF4-FFF2-40B4-BE49-F238E27FC236}">
                <a16:creationId xmlns:a16="http://schemas.microsoft.com/office/drawing/2014/main" id="{891C6471-FC74-6D79-2C87-52AC88FDD7EE}"/>
              </a:ext>
            </a:extLst>
          </p:cNvPr>
          <p:cNvSpPr>
            <a:spLocks noGrp="1" noChangeArrowheads="1"/>
          </p:cNvSpPr>
          <p:nvPr>
            <p:ph type="title"/>
          </p:nvPr>
        </p:nvSpPr>
        <p:spPr bwMode="auto">
          <a:xfrm>
            <a:off x="628650" y="274638"/>
            <a:ext cx="7886700" cy="993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ar-YE"/>
              <a:t>Click to edit Master title style</a:t>
            </a:r>
          </a:p>
        </p:txBody>
      </p:sp>
      <p:sp>
        <p:nvSpPr>
          <p:cNvPr id="1027" name="Text Placeholder 2">
            <a:extLst>
              <a:ext uri="{FF2B5EF4-FFF2-40B4-BE49-F238E27FC236}">
                <a16:creationId xmlns:a16="http://schemas.microsoft.com/office/drawing/2014/main" id="{D8CC31AA-3859-B8A0-D401-40D861F2336B}"/>
              </a:ext>
            </a:extLst>
          </p:cNvPr>
          <p:cNvSpPr>
            <a:spLocks noGrp="1"/>
          </p:cNvSpPr>
          <p:nvPr>
            <p:ph type="body" idx="1"/>
          </p:nvPr>
        </p:nvSpPr>
        <p:spPr bwMode="auto">
          <a:xfrm>
            <a:off x="628650" y="1370013"/>
            <a:ext cx="7886700" cy="3262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ar-YE"/>
              <a:t>Click to edit Master text styles</a:t>
            </a:r>
          </a:p>
          <a:p>
            <a:pPr lvl="1"/>
            <a:r>
              <a:rPr lang="en-US" altLang="ar-YE"/>
              <a:t>Second level</a:t>
            </a:r>
          </a:p>
          <a:p>
            <a:pPr lvl="2"/>
            <a:r>
              <a:rPr lang="en-US" altLang="ar-YE"/>
              <a:t>Third level</a:t>
            </a:r>
          </a:p>
          <a:p>
            <a:pPr lvl="3"/>
            <a:r>
              <a:rPr lang="en-US" altLang="ar-YE"/>
              <a:t>Fourth level</a:t>
            </a:r>
          </a:p>
          <a:p>
            <a:pPr lvl="4"/>
            <a:r>
              <a:rPr lang="en-US" altLang="ar-YE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3B8E075-2ED6-59B5-B9E8-D858F6E7C3F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628650" y="4767263"/>
            <a:ext cx="2057400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900">
                <a:solidFill>
                  <a:schemeClr val="tx1">
                    <a:tint val="82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82514F9A-75F6-4D34-B512-92A57F93648C}" type="datetimeFigureOut">
              <a:rPr lang="ar-YE"/>
              <a:pPr>
                <a:defRPr/>
              </a:pPr>
              <a:t>21/11/1447</a:t>
            </a:fld>
            <a:endParaRPr lang="ar-Y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9454FD9-1F2E-5D95-FFFC-341D9B97B65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028950" y="4767263"/>
            <a:ext cx="3086100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eaLnBrk="1" fontAlgn="auto" hangingPunct="1">
              <a:spcBef>
                <a:spcPts val="0"/>
              </a:spcBef>
              <a:spcAft>
                <a:spcPts val="0"/>
              </a:spcAft>
              <a:defRPr sz="900">
                <a:solidFill>
                  <a:schemeClr val="tx1">
                    <a:tint val="82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ar-Y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AE5039F-C134-F82E-C2F4-3E2B8CF6B5D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457950" y="4767263"/>
            <a:ext cx="2057400" cy="274637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 eaLnBrk="1" hangingPunct="1">
              <a:defRPr sz="900">
                <a:solidFill>
                  <a:srgbClr val="767676"/>
                </a:solidFill>
              </a:defRPr>
            </a:lvl1pPr>
          </a:lstStyle>
          <a:p>
            <a:fld id="{B232C4A3-EF3D-4E57-A5A9-C8A551E1D9FA}" type="slidenum">
              <a:rPr lang="ar-YE" altLang="ar-YE"/>
              <a:pPr/>
              <a:t>‹#›</a:t>
            </a:fld>
            <a:endParaRPr lang="ar-YE" altLang="ar-Y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1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  <a:lvl2pPr algn="l" defTabSz="685800" rtl="1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Aptos Display" pitchFamily="34" charset="0"/>
        </a:defRPr>
      </a:lvl2pPr>
      <a:lvl3pPr algn="l" defTabSz="685800" rtl="1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Aptos Display" pitchFamily="34" charset="0"/>
        </a:defRPr>
      </a:lvl3pPr>
      <a:lvl4pPr algn="l" defTabSz="685800" rtl="1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Aptos Display" pitchFamily="34" charset="0"/>
        </a:defRPr>
      </a:lvl4pPr>
      <a:lvl5pPr algn="l" defTabSz="685800" rtl="1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Aptos Display" pitchFamily="34" charset="0"/>
        </a:defRPr>
      </a:lvl5pPr>
      <a:lvl6pPr marL="457200" algn="l" defTabSz="685800" rtl="1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Aptos Display" pitchFamily="34" charset="0"/>
        </a:defRPr>
      </a:lvl6pPr>
      <a:lvl7pPr marL="914400" algn="l" defTabSz="685800" rtl="1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Aptos Display" pitchFamily="34" charset="0"/>
        </a:defRPr>
      </a:lvl7pPr>
      <a:lvl8pPr marL="1371600" algn="l" defTabSz="685800" rtl="1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Aptos Display" pitchFamily="34" charset="0"/>
        </a:defRPr>
      </a:lvl8pPr>
      <a:lvl9pPr marL="1828800" algn="l" defTabSz="685800" rtl="1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Aptos Display" pitchFamily="34" charset="0"/>
        </a:defRPr>
      </a:lvl9pPr>
    </p:titleStyle>
    <p:bodyStyle>
      <a:lvl1pPr marL="171450" indent="-171450" algn="r" defTabSz="685800" rtl="1" eaLnBrk="0" fontAlgn="base" hangingPunct="0">
        <a:lnSpc>
          <a:spcPct val="90000"/>
        </a:lnSpc>
        <a:spcBef>
          <a:spcPts val="750"/>
        </a:spcBef>
        <a:spcAft>
          <a:spcPct val="0"/>
        </a:spcAft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r" defTabSz="685800" rtl="1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panose="020B0604020202020204" pitchFamily="34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r" defTabSz="685800" rtl="1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r" defTabSz="685800" rtl="1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panose="020B0604020202020204" pitchFamily="34" charset="0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r" defTabSz="685800" rtl="1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panose="020B0604020202020204" pitchFamily="34" charset="0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62D22EF-9D8B-E0F7-E471-C5792CEBAA0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515FC8A-B284-1327-16BC-B7E8C784F3B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 algn="l" rtl="0">
              <a:buNone/>
            </a:pPr>
            <a:r>
              <a:rPr lang="nl-NL" sz="1800" b="1" dirty="0">
                <a:cs typeface="+mj-cs"/>
              </a:rPr>
              <a:t>Figure S2.2. </a:t>
            </a:r>
            <a:r>
              <a:rPr lang="nl-NL" sz="1800" dirty="0">
                <a:cs typeface="+mj-cs"/>
              </a:rPr>
              <a:t>Multi-group confirmatory factor analysis testing measurement invariance across public (n = 304) and private (n = 222) hospital nurses. The diagram displays the configural model (baseline). Metric invariance (</a:t>
            </a:r>
            <a:r>
              <a:rPr lang="el-GR" sz="1800" dirty="0">
                <a:cs typeface="+mj-cs"/>
              </a:rPr>
              <a:t>Δ</a:t>
            </a:r>
            <a:r>
              <a:rPr lang="nl-NL" sz="1800" dirty="0">
                <a:cs typeface="+mj-cs"/>
              </a:rPr>
              <a:t>CFI = 0.002) and scalar invariance (</a:t>
            </a:r>
            <a:r>
              <a:rPr lang="el-GR" sz="1800" dirty="0">
                <a:cs typeface="+mj-cs"/>
              </a:rPr>
              <a:t>Δ</a:t>
            </a:r>
            <a:r>
              <a:rPr lang="nl-NL" sz="1800" dirty="0">
                <a:cs typeface="+mj-cs"/>
              </a:rPr>
              <a:t>CFI = 0.008) were both supported. CFI, comparative fit index.</a:t>
            </a:r>
            <a:endParaRPr lang="ar-YE" sz="1800" dirty="0">
              <a:cs typeface="+mj-cs"/>
            </a:endParaRPr>
          </a:p>
        </p:txBody>
      </p:sp>
    </p:spTree>
    <p:extLst>
      <p:ext uri="{BB962C8B-B14F-4D97-AF65-F5344CB8AC3E}">
        <p14:creationId xmlns:p14="http://schemas.microsoft.com/office/powerpoint/2010/main" val="89915010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8455A990-C08F-801C-7672-AD687E45A64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/>
        </p:blipFill>
        <p:spPr>
          <a:xfrm>
            <a:off x="198304" y="-3444"/>
            <a:ext cx="8615189" cy="5230651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1</TotalTime>
  <Words>63</Words>
  <Application>Microsoft Office PowerPoint</Application>
  <PresentationFormat>On-screen Show (16:9)</PresentationFormat>
  <Paragraphs>1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ptos</vt:lpstr>
      <vt:lpstr>Aptos Display</vt:lpstr>
      <vt:lpstr>Arial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عرض تقديمي في PowerPoint</dc:title>
  <dc:creator>Haitham Jowah</dc:creator>
  <cp:lastModifiedBy>Haitham Jowah</cp:lastModifiedBy>
  <cp:revision>8</cp:revision>
  <dcterms:created xsi:type="dcterms:W3CDTF">2026-05-06T20:22:58Z</dcterms:created>
  <dcterms:modified xsi:type="dcterms:W3CDTF">2026-05-07T01:42:00Z</dcterms:modified>
</cp:coreProperties>
</file>